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75C78-55B2-4902-9374-67C97ECA3A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ACD6B4-32B4-4C9A-95EA-780514D4FA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D339A-D59C-47F6-9FCD-30835935DD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683C6-6320-4C5A-8150-F42DACFD6C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63381-161D-4742-8AAB-F75E53B5B9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329C3-977C-48EC-BC48-5512B722F6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C0D40-AD59-4BB3-A172-0F426129CD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EE21F-4B91-401A-AAD4-A66C222F39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79E34-4E50-448E-B452-CA837F372F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C825E-796F-472E-A8C0-D019E381F4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1D89D-6FB7-420D-A42E-AB405BF45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AD0CE-D3E7-4F83-A5A8-DF7F9BFD50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2DC625-7595-4659-ABFD-9DE6AE89E95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30080" y="7337520"/>
            <a:ext cx="50230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e expression in muscl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. Skeletal muscle mRNA levels from different genes from 16 wk-age male wild type, ob/ob, 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 KO and POKO mice fed chow (n=6-8). § P=0.09 ob/ob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WT, ** P&lt;0.01 POK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ob/ob, ## P&lt;0.01 POK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WT, ### P&lt;0.001 POK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WT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1920960" y="6180120"/>
            <a:ext cx="84924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916280" y="6173640"/>
            <a:ext cx="8492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920960" y="5602320"/>
            <a:ext cx="73476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916280" y="5597640"/>
            <a:ext cx="73332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1920960" y="5025960"/>
            <a:ext cx="57132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916280" y="5019840"/>
            <a:ext cx="571320" cy="1062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920960" y="4451400"/>
            <a:ext cx="59508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916280" y="4446720"/>
            <a:ext cx="59508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920960" y="3875040"/>
            <a:ext cx="207468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916280" y="3868560"/>
            <a:ext cx="2073240" cy="10512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920960" y="3297240"/>
            <a:ext cx="48096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916280" y="3292560"/>
            <a:ext cx="47916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920960" y="2720880"/>
            <a:ext cx="36828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916280" y="2714760"/>
            <a:ext cx="36648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920960" y="6075360"/>
            <a:ext cx="93960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916280" y="6068880"/>
            <a:ext cx="93816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1920960" y="5497560"/>
            <a:ext cx="75240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1916280" y="5492880"/>
            <a:ext cx="75240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920960" y="4921200"/>
            <a:ext cx="79200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916280" y="4915080"/>
            <a:ext cx="79200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1920960" y="4346640"/>
            <a:ext cx="86508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916280" y="4341960"/>
            <a:ext cx="86508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920960" y="3768840"/>
            <a:ext cx="1677960" cy="1062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1916280" y="3763800"/>
            <a:ext cx="167796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1920960" y="3192480"/>
            <a:ext cx="50616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1916280" y="3187800"/>
            <a:ext cx="50616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1920960" y="2616120"/>
            <a:ext cx="40644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1916280" y="2610000"/>
            <a:ext cx="40608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1920960" y="2041560"/>
            <a:ext cx="124596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1916280" y="2036880"/>
            <a:ext cx="124596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1920960" y="5969160"/>
            <a:ext cx="973080" cy="106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1916280" y="5964120"/>
            <a:ext cx="97308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1920960" y="5392800"/>
            <a:ext cx="68400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1916280" y="5388120"/>
            <a:ext cx="68400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1920960" y="4818240"/>
            <a:ext cx="83484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1916280" y="4813200"/>
            <a:ext cx="833400" cy="10188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920960" y="4241880"/>
            <a:ext cx="60300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1916280" y="4237200"/>
            <a:ext cx="60300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1920960" y="3664080"/>
            <a:ext cx="124128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1916280" y="3659040"/>
            <a:ext cx="12398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1920960" y="3087720"/>
            <a:ext cx="64620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1916280" y="3083040"/>
            <a:ext cx="64440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1920960" y="2513160"/>
            <a:ext cx="54108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1916280" y="2508120"/>
            <a:ext cx="539640" cy="10188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1920960" y="586440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1916280" y="585936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1920960" y="528804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1916280" y="528336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920960" y="4713120"/>
            <a:ext cx="795240" cy="105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1916280" y="470844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1920960" y="413712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1916280" y="4130640"/>
            <a:ext cx="793440" cy="1065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920960" y="355932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916280" y="355428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1920960" y="298296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916280" y="297828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1920960" y="240840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916280" y="240336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920960" y="1832040"/>
            <a:ext cx="79524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916280" y="1825560"/>
            <a:ext cx="793440" cy="10476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765520" y="6226200"/>
            <a:ext cx="18396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949480" y="619272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649600" y="5649840"/>
            <a:ext cx="475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2697120" y="561492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2487600" y="5073480"/>
            <a:ext cx="9360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581200" y="503856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2511360" y="4495680"/>
            <a:ext cx="6516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2576520" y="446256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3989520" y="3919680"/>
            <a:ext cx="29196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281480" y="388476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2395440" y="3341520"/>
            <a:ext cx="4284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2438280" y="3308400"/>
            <a:ext cx="180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2282760" y="2765520"/>
            <a:ext cx="446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2327400" y="273060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2854440" y="6121440"/>
            <a:ext cx="2048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3059280" y="608796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2668680" y="5545080"/>
            <a:ext cx="601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728800" y="551016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2708280" y="4967280"/>
            <a:ext cx="14436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2852640" y="493380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2781360" y="4390920"/>
            <a:ext cx="763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2857680" y="4357800"/>
            <a:ext cx="1440" cy="666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3594240" y="3814920"/>
            <a:ext cx="24588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840120" y="3780000"/>
            <a:ext cx="180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422440" y="3236760"/>
            <a:ext cx="493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2471760" y="320364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322360" y="2660760"/>
            <a:ext cx="2880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2351160" y="262584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162240" y="2089080"/>
            <a:ext cx="29376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3456000" y="205416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2889360" y="6016680"/>
            <a:ext cx="35388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3243240" y="598320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2600280" y="5440320"/>
            <a:ext cx="6840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2668680" y="540540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2749680" y="4862520"/>
            <a:ext cx="2156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2965320" y="482904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519280" y="4286160"/>
            <a:ext cx="9216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2611440" y="425124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3156120" y="3708360"/>
            <a:ext cx="22860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3384720" y="367524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2560680" y="3132000"/>
            <a:ext cx="11124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2671920" y="3098880"/>
            <a:ext cx="144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2455920" y="2557440"/>
            <a:ext cx="554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2511360" y="252396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2709720" y="5911920"/>
            <a:ext cx="1526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2862360" y="587844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2709720" y="5335560"/>
            <a:ext cx="716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2781360" y="530064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2709720" y="4757760"/>
            <a:ext cx="7956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2789280" y="472428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709720" y="4181400"/>
            <a:ext cx="8280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2792520" y="414648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2709720" y="3603600"/>
            <a:ext cx="842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2793960" y="3570120"/>
            <a:ext cx="180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2709720" y="3027240"/>
            <a:ext cx="9216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2801880" y="2994120"/>
            <a:ext cx="1800" cy="666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2709720" y="2455920"/>
            <a:ext cx="12384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2833560" y="2421000"/>
            <a:ext cx="1800" cy="680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2709720" y="1878120"/>
            <a:ext cx="12096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2830680" y="1844640"/>
            <a:ext cx="1440" cy="684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1916280" y="6357960"/>
            <a:ext cx="317340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1916280" y="6357600"/>
            <a:ext cx="1440" cy="363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2709720" y="6357600"/>
            <a:ext cx="1800" cy="363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3502080" y="6357600"/>
            <a:ext cx="1440" cy="363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4297320" y="6357600"/>
            <a:ext cx="1800" cy="363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5089680" y="6357600"/>
            <a:ext cx="1440" cy="363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1916280" y="1747800"/>
            <a:ext cx="1440" cy="461016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1879560" y="635796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1879560" y="5781600"/>
            <a:ext cx="367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1879560" y="520380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1879560" y="462924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1879560" y="405288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1879560" y="347508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1879560" y="2898720"/>
            <a:ext cx="367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1879560" y="2324160"/>
            <a:ext cx="36720" cy="14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1879560" y="1747800"/>
            <a:ext cx="3672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2646000" y="1376280"/>
            <a:ext cx="1639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e expression in muscl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1882440" y="647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2676240" y="647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3468240" y="647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4263840" y="647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5054400" y="6472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1523880" y="5999040"/>
            <a:ext cx="27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OX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1356480" y="5423040"/>
            <a:ext cx="41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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1356120" y="4848120"/>
            <a:ext cx="43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1573200" y="427212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PL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1444680" y="369396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UCP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1355400" y="3117960"/>
            <a:ext cx="42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GC1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1187640" y="2543040"/>
            <a:ext cx="575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REBP1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1276560" y="1967040"/>
            <a:ext cx="498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ARg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2907360" y="6694560"/>
            <a:ext cx="1145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5243400" y="3695760"/>
            <a:ext cx="676440" cy="726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5276880" y="3747960"/>
            <a:ext cx="76320" cy="76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5275440" y="3746520"/>
            <a:ext cx="80640" cy="810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5383800" y="371808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5276880" y="3929040"/>
            <a:ext cx="7632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5275440" y="3927600"/>
            <a:ext cx="80640" cy="810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5374080" y="3898800"/>
            <a:ext cx="68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K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5276880" y="4110120"/>
            <a:ext cx="76320" cy="759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5275440" y="4108320"/>
            <a:ext cx="80640" cy="810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383080" y="4079880"/>
            <a:ext cx="34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b/o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5276880" y="4290840"/>
            <a:ext cx="76320" cy="763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5275440" y="4289400"/>
            <a:ext cx="80640" cy="810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5382720" y="4260960"/>
            <a:ext cx="37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OK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2589840" y="4433760"/>
            <a:ext cx="31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3504960" y="2019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§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2311200" y="26496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2425680" y="3241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##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4335120" y="37972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###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5481000" y="838692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18:57Z</dcterms:modified>
  <cp:revision>68</cp:revision>
  <dc:subject/>
  <dc:title>PowerPoint Presentation</dc:title>
</cp:coreProperties>
</file>